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3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3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79512" y="5520714"/>
            <a:ext cx="691276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Liarakos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203-7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The use of technology in type 2 diabetes and prediabet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7C0DC59-2CF0-DCF1-DEC3-E7FEED90488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5696" y="764704"/>
            <a:ext cx="5472608" cy="4934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7</cp:revision>
  <dcterms:created xsi:type="dcterms:W3CDTF">2016-06-15T12:53:43Z</dcterms:created>
  <dcterms:modified xsi:type="dcterms:W3CDTF">2024-06-13T15:36:16Z</dcterms:modified>
</cp:coreProperties>
</file>